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media/image7.wmf" ContentType="image/x-wmf"/>
  <Override PartName="/ppt/media/image8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8121650" cy="1620361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27755-9C6D-46CC-8F66-B7A0F4B5EC0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06440" y="936576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B6237A-FF23-48BE-94FA-8801E99A2D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15080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20DA0B-B811-4EF1-9255-9473AD026E9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87712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347800" y="378108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0644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87712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347800" y="9365760"/>
            <a:ext cx="23526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00595C-79AB-498F-BB19-5E18A4CD14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817AD7-EDE9-492F-AB40-B604564EC2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F7EC3F-5CE1-4F21-8078-F3884CA2C3C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C28583-4F49-4DAF-8205-488EBF986D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F46EF2-9023-4954-AD31-30C49209D45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06440" y="649080"/>
            <a:ext cx="7307280" cy="125186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44ED50-9DE1-4C34-8AA7-41441D7999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2D71E9-26B1-4BCA-9AB3-21311479142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150800" y="936576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ACDD03-D96B-437C-BD6A-644B532B9AF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0644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150800" y="3781080"/>
            <a:ext cx="356580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06440" y="9365760"/>
            <a:ext cx="7307280" cy="5099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DF36D8-869F-4778-ABA4-6D933330089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06440" y="649080"/>
            <a:ext cx="7307280" cy="27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06440" y="3781080"/>
            <a:ext cx="7307280" cy="10691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06080" y="14755680"/>
            <a:ext cx="189396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774880" y="14755680"/>
            <a:ext cx="257040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5819400" y="14755680"/>
            <a:ext cx="1893960" cy="1123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2A3FC4C-EC38-4463-8E20-6EC697CFAB88}" type="slidenum">
              <a:rPr b="0" lang="zh-TW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wmf"/><Relationship Id="rId3" Type="http://schemas.openxmlformats.org/officeDocument/2006/relationships/package" Target="../embeddings/oleObject2.xlsx"/><Relationship Id="rId4" Type="http://schemas.openxmlformats.org/officeDocument/2006/relationships/image" Target="../media/image2.wmf"/><Relationship Id="rId5" Type="http://schemas.openxmlformats.org/officeDocument/2006/relationships/package" Target="../embeddings/oleObject3.xlsx"/><Relationship Id="rId6" Type="http://schemas.openxmlformats.org/officeDocument/2006/relationships/image" Target="../media/image3.wmf"/><Relationship Id="rId7" Type="http://schemas.openxmlformats.org/officeDocument/2006/relationships/package" Target="../embeddings/oleObject4.xlsx"/><Relationship Id="rId8" Type="http://schemas.openxmlformats.org/officeDocument/2006/relationships/image" Target="../media/image4.wmf"/><Relationship Id="rId9" Type="http://schemas.openxmlformats.org/officeDocument/2006/relationships/package" Target="../embeddings/oleObject5.xlsx"/><Relationship Id="rId10" Type="http://schemas.openxmlformats.org/officeDocument/2006/relationships/image" Target="../media/image5.wmf"/><Relationship Id="rId11" Type="http://schemas.openxmlformats.org/officeDocument/2006/relationships/package" Target="../embeddings/oleObject6.xlsx"/><Relationship Id="rId12" Type="http://schemas.openxmlformats.org/officeDocument/2006/relationships/image" Target="../media/image6.wmf"/><Relationship Id="rId13" Type="http://schemas.openxmlformats.org/officeDocument/2006/relationships/package" Target="../embeddings/oleObject7.xlsx"/><Relationship Id="rId14" Type="http://schemas.openxmlformats.org/officeDocument/2006/relationships/image" Target="../media/image7.wmf"/><Relationship Id="rId15" Type="http://schemas.openxmlformats.org/officeDocument/2006/relationships/package" Target="../embeddings/oleObject8.xlsx"/><Relationship Id="rId16" Type="http://schemas.openxmlformats.org/officeDocument/2006/relationships/image" Target="../media/image8.wmf"/><Relationship Id="rId17" Type="http://schemas.openxmlformats.org/officeDocument/2006/relationships/slideLayout" Target="../slideLayouts/slideLayout1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819000" y="6229440"/>
          <a:ext cx="6697800" cy="863640"/>
        </p:xfrm>
        <a:graphic>
          <a:graphicData uri="http://schemas.openxmlformats.org/presentationml/2006/ole">
            <p:oleObj progId="Excel.Sheet.12" r:id="rId1" spid="">
              <p:embed/>
              <p:pic>
                <p:nvPicPr>
                  <p:cNvPr id="42" name="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819000" y="6229440"/>
                    <a:ext cx="6697800" cy="863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723960" y="5230800"/>
          <a:ext cx="6767280" cy="960480"/>
        </p:xfrm>
        <a:graphic>
          <a:graphicData uri="http://schemas.openxmlformats.org/presentationml/2006/ole">
            <p:oleObj progId="Excel.Sheet.12" r:id="rId3" spid="">
              <p:embed/>
              <p:pic>
                <p:nvPicPr>
                  <p:cNvPr id="44" name="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723960" y="5230800"/>
                    <a:ext cx="6767280" cy="9604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"/>
          <p:cNvGraphicFramePr/>
          <p:nvPr/>
        </p:nvGraphicFramePr>
        <p:xfrm>
          <a:off x="722160" y="10175760"/>
          <a:ext cx="6769080" cy="831960"/>
        </p:xfrm>
        <a:graphic>
          <a:graphicData uri="http://schemas.openxmlformats.org/presentationml/2006/ole">
            <p:oleObj progId="Excel.Sheet.12" r:id="rId5" spid="">
              <p:embed/>
              <p:pic>
                <p:nvPicPr>
                  <p:cNvPr id="46" name="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722160" y="10175760"/>
                    <a:ext cx="6769080" cy="8319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7" name=""/>
          <p:cNvGraphicFramePr/>
          <p:nvPr/>
        </p:nvGraphicFramePr>
        <p:xfrm>
          <a:off x="727200" y="9404280"/>
          <a:ext cx="6769080" cy="847800"/>
        </p:xfrm>
        <a:graphic>
          <a:graphicData uri="http://schemas.openxmlformats.org/presentationml/2006/ole">
            <p:oleObj progId="Excel.Sheet.12" r:id="rId7" spid="">
              <p:embed/>
              <p:pic>
                <p:nvPicPr>
                  <p:cNvPr id="48" name="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727200" y="9404280"/>
                    <a:ext cx="6769080" cy="8478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9" name=""/>
          <p:cNvGraphicFramePr/>
          <p:nvPr/>
        </p:nvGraphicFramePr>
        <p:xfrm>
          <a:off x="722160" y="8618400"/>
          <a:ext cx="6769080" cy="857520"/>
        </p:xfrm>
        <a:graphic>
          <a:graphicData uri="http://schemas.openxmlformats.org/presentationml/2006/ole">
            <p:oleObj progId="Excel.Sheet.12" r:id="rId9" spid="">
              <p:embed/>
              <p:pic>
                <p:nvPicPr>
                  <p:cNvPr id="50" name="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722160" y="8618400"/>
                    <a:ext cx="6769080" cy="857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1" name=""/>
          <p:cNvGraphicFramePr/>
          <p:nvPr/>
        </p:nvGraphicFramePr>
        <p:xfrm>
          <a:off x="682560" y="1332000"/>
          <a:ext cx="6834240" cy="4024080"/>
        </p:xfrm>
        <a:graphic>
          <a:graphicData uri="http://schemas.openxmlformats.org/presentationml/2006/ole">
            <p:oleObj progId="Excel.Sheet.12" r:id="rId11" spid="">
              <p:embed/>
              <p:pic>
                <p:nvPicPr>
                  <p:cNvPr id="52" name="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682560" y="1332000"/>
                    <a:ext cx="6834240" cy="4024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3" name=""/>
          <p:cNvGraphicFramePr/>
          <p:nvPr/>
        </p:nvGraphicFramePr>
        <p:xfrm>
          <a:off x="819000" y="7877160"/>
          <a:ext cx="6697800" cy="863640"/>
        </p:xfrm>
        <a:graphic>
          <a:graphicData uri="http://schemas.openxmlformats.org/presentationml/2006/ole">
            <p:oleObj progId="Excel.Sheet.12" r:id="rId13" spid="">
              <p:embed/>
              <p:pic>
                <p:nvPicPr>
                  <p:cNvPr id="54" name="" descr=""/>
                  <p:cNvPicPr/>
                  <p:nvPr/>
                </p:nvPicPr>
                <p:blipFill>
                  <a:blip r:embed="rId14"/>
                  <a:stretch/>
                </p:blipFill>
                <p:spPr>
                  <a:xfrm>
                    <a:off x="819000" y="7877160"/>
                    <a:ext cx="6697800" cy="863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5" name=""/>
          <p:cNvGraphicFramePr/>
          <p:nvPr/>
        </p:nvGraphicFramePr>
        <p:xfrm>
          <a:off x="727200" y="7047000"/>
          <a:ext cx="6769080" cy="876240"/>
        </p:xfrm>
        <a:graphic>
          <a:graphicData uri="http://schemas.openxmlformats.org/presentationml/2006/ole">
            <p:oleObj progId="Excel.Sheet.12" r:id="rId15" spid="">
              <p:embed/>
              <p:pic>
                <p:nvPicPr>
                  <p:cNvPr id="56" name="" descr=""/>
                  <p:cNvPicPr/>
                  <p:nvPr/>
                </p:nvPicPr>
                <p:blipFill>
                  <a:blip r:embed="rId16"/>
                  <a:stretch/>
                </p:blipFill>
                <p:spPr>
                  <a:xfrm>
                    <a:off x="727200" y="7047000"/>
                    <a:ext cx="6769080" cy="876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7" name=""/>
          <p:cNvSpPr/>
          <p:nvPr/>
        </p:nvSpPr>
        <p:spPr>
          <a:xfrm>
            <a:off x="317520" y="147636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317520" y="529272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317880" y="622944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317880" y="1018872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317880" y="7093080"/>
            <a:ext cx="345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317520" y="802944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317520" y="8677440"/>
            <a:ext cx="320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317520" y="9469440"/>
            <a:ext cx="358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-44280" y="11041200"/>
            <a:ext cx="8164440" cy="3503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zh-TW" sz="1400" spc="-1" strike="noStrike">
                <a:solidFill>
                  <a:srgbClr val="000000"/>
                </a:solidFill>
                <a:latin typeface="Arial"/>
              </a:rPr>
              <a:t>S3 Fig. Distribution plot of intergroup distance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Frequency distribution plots that calculated by comparing p-distance between isolates of each group to isolates of other groups. Y axis represents the frequency counts in each bin. X axis represents the value of uncorrected pairwise distance. Dash lines indicated the border line at 0.3750 and 0.3950 (see description in main article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A) An overall distance distribution of TTV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B) Distribution plot of evolutionary distances that calculated by comparing group 6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C) Distribution plot of evolutionary distances that calculated by comparing group 7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D) Distribution plot of evolutionary distances that calculated by comparing group 1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E) Distribution plot of evolutionary distances that calculated by comparing group 2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F) Distribution plot of evolutionary distances that calculated by comparing group 3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G) Distribution plot of evolutionary distances that calculated by comparing group 4 strains to others.</a:t>
            </a:r>
            <a:br>
              <a:rPr sz="1400"/>
            </a:b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(H) Distribution plot of evolutionary distances that calculated by comparing group 5 strains to others.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* 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The Y axis of (B) to (H) are not in accordance with actual proportion</a:t>
            </a:r>
            <a:r>
              <a:rPr b="0" lang="zh-TW" sz="14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 rot="10800000">
            <a:off x="316080" y="2412720"/>
            <a:ext cx="454680" cy="1260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 vert="eaVer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requency*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3774240" y="5213520"/>
            <a:ext cx="624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ins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"/>
          <p:cNvSpPr/>
          <p:nvPr/>
        </p:nvSpPr>
        <p:spPr>
          <a:xfrm>
            <a:off x="5356080" y="1547640"/>
            <a:ext cx="262080" cy="9361800"/>
          </a:xfrm>
          <a:prstGeom prst="rect">
            <a:avLst/>
          </a:prstGeom>
          <a:noFill/>
          <a:ln w="936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"/>
          <p:cNvSpPr/>
          <p:nvPr/>
        </p:nvSpPr>
        <p:spPr>
          <a:xfrm>
            <a:off x="2569680" y="811080"/>
            <a:ext cx="2235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Within phylogenetic gro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"/>
          <p:cNvSpPr/>
          <p:nvPr/>
        </p:nvSpPr>
        <p:spPr>
          <a:xfrm>
            <a:off x="1225440" y="1547640"/>
            <a:ext cx="6218280" cy="93618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1" name=""/>
          <p:cNvGrpSpPr/>
          <p:nvPr/>
        </p:nvGrpSpPr>
        <p:grpSpPr>
          <a:xfrm>
            <a:off x="5356080" y="900000"/>
            <a:ext cx="2086200" cy="288720"/>
            <a:chOff x="5356080" y="900000"/>
            <a:chExt cx="2086200" cy="288720"/>
          </a:xfrm>
        </p:grpSpPr>
        <p:grpSp>
          <p:nvGrpSpPr>
            <p:cNvPr id="72" name=""/>
            <p:cNvGrpSpPr/>
            <p:nvPr/>
          </p:nvGrpSpPr>
          <p:grpSpPr>
            <a:xfrm>
              <a:off x="5356080" y="1044360"/>
              <a:ext cx="2086200" cy="144360"/>
              <a:chOff x="5356080" y="1044360"/>
              <a:chExt cx="2086200" cy="144360"/>
            </a:xfrm>
          </p:grpSpPr>
          <p:sp>
            <p:nvSpPr>
              <p:cNvPr id="73" name=""/>
              <p:cNvSpPr/>
              <p:nvPr/>
            </p:nvSpPr>
            <p:spPr>
              <a:xfrm>
                <a:off x="5356080" y="1044360"/>
                <a:ext cx="208620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5356080" y="104436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7442280" y="104436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" name=""/>
            <p:cNvSpPr/>
            <p:nvPr/>
          </p:nvSpPr>
          <p:spPr>
            <a:xfrm>
              <a:off x="6394680" y="900000"/>
              <a:ext cx="0" cy="14436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7" name=""/>
          <p:cNvGrpSpPr/>
          <p:nvPr/>
        </p:nvGrpSpPr>
        <p:grpSpPr>
          <a:xfrm>
            <a:off x="1251000" y="1189080"/>
            <a:ext cx="4388760" cy="288360"/>
            <a:chOff x="1251000" y="1189080"/>
            <a:chExt cx="4388760" cy="288360"/>
          </a:xfrm>
        </p:grpSpPr>
        <p:grpSp>
          <p:nvGrpSpPr>
            <p:cNvPr id="78" name=""/>
            <p:cNvGrpSpPr/>
            <p:nvPr/>
          </p:nvGrpSpPr>
          <p:grpSpPr>
            <a:xfrm>
              <a:off x="1251000" y="1333080"/>
              <a:ext cx="4388760" cy="144360"/>
              <a:chOff x="1251000" y="1333080"/>
              <a:chExt cx="4388760" cy="144360"/>
            </a:xfrm>
          </p:grpSpPr>
          <p:sp>
            <p:nvSpPr>
              <p:cNvPr id="79" name=""/>
              <p:cNvSpPr/>
              <p:nvPr/>
            </p:nvSpPr>
            <p:spPr>
              <a:xfrm>
                <a:off x="1251000" y="1333080"/>
                <a:ext cx="4388760" cy="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1251000" y="133308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" name=""/>
              <p:cNvSpPr/>
              <p:nvPr/>
            </p:nvSpPr>
            <p:spPr>
              <a:xfrm>
                <a:off x="5639760" y="1333080"/>
                <a:ext cx="0" cy="144360"/>
              </a:xfrm>
              <a:prstGeom prst="line">
                <a:avLst/>
              </a:prstGeom>
              <a:ln w="255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" name=""/>
            <p:cNvSpPr/>
            <p:nvPr/>
          </p:nvSpPr>
          <p:spPr>
            <a:xfrm>
              <a:off x="3436560" y="1189080"/>
              <a:ext cx="0" cy="144000"/>
            </a:xfrm>
            <a:prstGeom prst="line">
              <a:avLst/>
            </a:prstGeom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3" name=""/>
          <p:cNvSpPr/>
          <p:nvPr/>
        </p:nvSpPr>
        <p:spPr>
          <a:xfrm>
            <a:off x="5278680" y="523800"/>
            <a:ext cx="2433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Between phylogenetic group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92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6-05T03:41:55Z</dcterms:created>
  <dc:creator> </dc:creator>
  <dc:description/>
  <dc:language>en-US</dc:language>
  <cp:lastModifiedBy> </cp:lastModifiedBy>
  <dcterms:modified xsi:type="dcterms:W3CDTF">2016-02-12T07:33:59Z</dcterms:modified>
  <cp:revision>42</cp:revision>
  <dc:subject/>
  <dc:title>投影片 1</dc:title>
</cp:coreProperties>
</file>